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3" d="100"/>
          <a:sy n="103" d="100"/>
        </p:scale>
        <p:origin x="-246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C10919-A887-42C6-83D9-3C06EFA6448B}" type="datetimeFigureOut">
              <a:rPr lang="en-US" smtClean="0"/>
              <a:t>3/2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5268C0-BF49-4869-9E01-1D2E1FEC496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C10919-A887-42C6-83D9-3C06EFA6448B}" type="datetimeFigureOut">
              <a:rPr lang="en-US" smtClean="0"/>
              <a:t>3/2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5268C0-BF49-4869-9E01-1D2E1FEC496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C10919-A887-42C6-83D9-3C06EFA6448B}" type="datetimeFigureOut">
              <a:rPr lang="en-US" smtClean="0"/>
              <a:t>3/2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5268C0-BF49-4869-9E01-1D2E1FEC496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C10919-A887-42C6-83D9-3C06EFA6448B}" type="datetimeFigureOut">
              <a:rPr lang="en-US" smtClean="0"/>
              <a:t>3/2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5268C0-BF49-4869-9E01-1D2E1FEC496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C10919-A887-42C6-83D9-3C06EFA6448B}" type="datetimeFigureOut">
              <a:rPr lang="en-US" smtClean="0"/>
              <a:t>3/2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5268C0-BF49-4869-9E01-1D2E1FEC496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C10919-A887-42C6-83D9-3C06EFA6448B}" type="datetimeFigureOut">
              <a:rPr lang="en-US" smtClean="0"/>
              <a:t>3/29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5268C0-BF49-4869-9E01-1D2E1FEC496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C10919-A887-42C6-83D9-3C06EFA6448B}" type="datetimeFigureOut">
              <a:rPr lang="en-US" smtClean="0"/>
              <a:t>3/29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5268C0-BF49-4869-9E01-1D2E1FEC496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C10919-A887-42C6-83D9-3C06EFA6448B}" type="datetimeFigureOut">
              <a:rPr lang="en-US" smtClean="0"/>
              <a:t>3/29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5268C0-BF49-4869-9E01-1D2E1FEC496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C10919-A887-42C6-83D9-3C06EFA6448B}" type="datetimeFigureOut">
              <a:rPr lang="en-US" smtClean="0"/>
              <a:t>3/29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5268C0-BF49-4869-9E01-1D2E1FEC496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C10919-A887-42C6-83D9-3C06EFA6448B}" type="datetimeFigureOut">
              <a:rPr lang="en-US" smtClean="0"/>
              <a:t>3/29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5268C0-BF49-4869-9E01-1D2E1FEC496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C10919-A887-42C6-83D9-3C06EFA6448B}" type="datetimeFigureOut">
              <a:rPr lang="en-US" smtClean="0"/>
              <a:t>3/29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5268C0-BF49-4869-9E01-1D2E1FEC496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C10919-A887-42C6-83D9-3C06EFA6448B}" type="datetimeFigureOut">
              <a:rPr lang="en-US" smtClean="0"/>
              <a:t>3/2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5268C0-BF49-4869-9E01-1D2E1FEC496E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3" name="Rectangle 5"/>
          <p:cNvSpPr>
            <a:spLocks noChangeArrowheads="1"/>
          </p:cNvSpPr>
          <p:nvPr/>
        </p:nvSpPr>
        <p:spPr bwMode="auto">
          <a:xfrm>
            <a:off x="1600200" y="1371600"/>
            <a:ext cx="6858000" cy="55399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914400" algn="l"/>
                <a:tab pos="1200150" algn="l"/>
              </a:tabLst>
            </a:pP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Calibri" pitchFamily="34" charset="0"/>
                <a:cs typeface="Times New Roman" pitchFamily="18" charset="0"/>
              </a:rPr>
              <a:t>Validation of molecular </a:t>
            </a:r>
            <a:r>
              <a:rPr kumimoji="0" lang="en-US" sz="120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Calibri" pitchFamily="34" charset="0"/>
                <a:cs typeface="Times New Roman" pitchFamily="18" charset="0"/>
              </a:rPr>
              <a:t>markerRM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Calibri" pitchFamily="34" charset="0"/>
                <a:cs typeface="Times New Roman" pitchFamily="18" charset="0"/>
              </a:rPr>
              <a:t> 6844 linked to the herbicide tolerant trait in popular Indian varieties</a:t>
            </a:r>
            <a:endParaRPr kumimoji="0" lang="en-US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914400" algn="l"/>
                <a:tab pos="1200150" algn="l"/>
              </a:tabLst>
            </a:pP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2049" name="Group 7"/>
          <p:cNvGrpSpPr>
            <a:grpSpLocks/>
          </p:cNvGrpSpPr>
          <p:nvPr/>
        </p:nvGrpSpPr>
        <p:grpSpPr bwMode="auto">
          <a:xfrm>
            <a:off x="2819400" y="2209800"/>
            <a:ext cx="3654425" cy="1649413"/>
            <a:chOff x="0" y="0"/>
            <a:chExt cx="41910" cy="24110"/>
          </a:xfrm>
        </p:grpSpPr>
        <p:pic>
          <p:nvPicPr>
            <p:cNvPr id="31" name="Picture 31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0" y="0"/>
              <a:ext cx="41910" cy="24110"/>
            </a:xfrm>
            <a:prstGeom prst="rect">
              <a:avLst/>
            </a:prstGeom>
            <a:noFill/>
          </p:spPr>
        </p:pic>
        <p:sp>
          <p:nvSpPr>
            <p:cNvPr id="33" name="Straight Arrow Connector 33"/>
            <p:cNvSpPr>
              <a:spLocks noChangeShapeType="1"/>
            </p:cNvSpPr>
            <p:nvPr/>
          </p:nvSpPr>
          <p:spPr bwMode="auto">
            <a:xfrm flipH="1">
              <a:off x="7722" y="10383"/>
              <a:ext cx="1404" cy="4640"/>
            </a:xfrm>
            <a:prstGeom prst="straightConnector1">
              <a:avLst/>
            </a:prstGeom>
            <a:noFill/>
            <a:ln w="9525">
              <a:solidFill>
                <a:srgbClr val="FF0000"/>
              </a:solidFill>
              <a:round/>
              <a:headEnd/>
              <a:tailEnd type="triangle" w="med" len="med"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5" name="Straight Arrow Connector 35"/>
            <p:cNvSpPr>
              <a:spLocks noChangeShapeType="1"/>
            </p:cNvSpPr>
            <p:nvPr/>
          </p:nvSpPr>
          <p:spPr bwMode="auto">
            <a:xfrm>
              <a:off x="88" y="15592"/>
              <a:ext cx="4367" cy="136"/>
            </a:xfrm>
            <a:prstGeom prst="straightConnector1">
              <a:avLst/>
            </a:prstGeom>
            <a:noFill/>
            <a:ln w="9525">
              <a:solidFill>
                <a:srgbClr val="FF0000"/>
              </a:solidFill>
              <a:round/>
              <a:headEnd/>
              <a:tailEnd type="triangle" w="med" len="med"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</p:grpSp>
      <p:sp>
        <p:nvSpPr>
          <p:cNvPr id="2054" name="Rectangle 6"/>
          <p:cNvSpPr>
            <a:spLocks noChangeArrowheads="1"/>
          </p:cNvSpPr>
          <p:nvPr/>
        </p:nvSpPr>
        <p:spPr bwMode="auto">
          <a:xfrm>
            <a:off x="990600" y="4038600"/>
            <a:ext cx="7772400" cy="12926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/>
            </a:r>
            <a:br>
              <a: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</a:b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Additional file 7</a:t>
            </a:r>
            <a:r>
              <a:rPr kumimoji="0" lang="en-US" sz="12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:  Figure S4: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Polymorphism survey between the popular Indian varieties (SH: </a:t>
            </a: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Sahabhagidhan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; HR: Herbicide tolerant mutant; N: Naveen; P: Pooja and SS1: </a:t>
            </a: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Swarna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Sub1) and the HTM using the linked marker RM 6844</a:t>
            </a:r>
            <a:endParaRPr kumimoji="0" lang="en-US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5</Words>
  <Application>Microsoft Office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ROBIN</dc:creator>
  <cp:lastModifiedBy>Balindan, Danica Joy</cp:lastModifiedBy>
  <cp:revision>3</cp:revision>
  <dcterms:created xsi:type="dcterms:W3CDTF">2016-12-07T16:29:06Z</dcterms:created>
  <dcterms:modified xsi:type="dcterms:W3CDTF">2017-03-29T13:57:06Z</dcterms:modified>
</cp:coreProperties>
</file>